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 varScale="1">
        <p:scale>
          <a:sx n="90" d="100"/>
          <a:sy n="90" d="100"/>
        </p:scale>
        <p:origin x="57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4C1DE8-415C-40C4-8330-8F92E729785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A419262-153F-4E20-AD8A-75AFF974ACF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altLang="ko-KR"/>
              <a:t>Click to edit Master subtitle style</a:t>
            </a:r>
            <a:endParaRPr lang="ko-KR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63F130-A62B-4ABE-A35B-58CB19208D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B379BD-B1BA-4FA8-939F-D2AD2CD65319}" type="datetimeFigureOut">
              <a:rPr lang="ko-KR" altLang="en-US" smtClean="0"/>
              <a:t>2022-12-29</a:t>
            </a:fld>
            <a:endParaRPr lang="ko-KR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3C15C7-24FC-4C5C-9053-EAEEAB5707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C61638-3792-464E-8045-5A3F3DF66B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B0409-ECCB-4A30-B8C5-01AE5091C75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056925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75D4D7-0FF4-4A2F-B26D-970077E3DD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9471293-ABAE-4514-B68D-898C1182AD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B0E05E-FF75-4352-B537-F2510BF7D1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B379BD-B1BA-4FA8-939F-D2AD2CD65319}" type="datetimeFigureOut">
              <a:rPr lang="ko-KR" altLang="en-US" smtClean="0"/>
              <a:t>2022-12-29</a:t>
            </a:fld>
            <a:endParaRPr lang="ko-KR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1626E3-766C-47DC-9A3E-0A210C56D0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3F0678-26EF-455F-94FB-0DD64B1C2E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B0409-ECCB-4A30-B8C5-01AE5091C75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821915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84C60B8-EF6E-4804-A4D2-8156820FAC6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0806614-9C01-4355-AACD-2FBAE3492EA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49CE03-CC78-4EBC-9864-5189CBBBA5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B379BD-B1BA-4FA8-939F-D2AD2CD65319}" type="datetimeFigureOut">
              <a:rPr lang="ko-KR" altLang="en-US" smtClean="0"/>
              <a:t>2022-12-29</a:t>
            </a:fld>
            <a:endParaRPr lang="ko-KR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C4D7CD-148D-4241-89CB-E011DFBE23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FADA3FA-E7FB-42A0-90B7-05687C81BC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B0409-ECCB-4A30-B8C5-01AE5091C75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209816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55F92C-9068-4AFB-8C0F-E261028631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ADA1F84-9EE4-4C35-B248-723D4D22F6E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790934-C2DF-46D7-851C-35CA40D1A2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B379BD-B1BA-4FA8-939F-D2AD2CD65319}" type="datetimeFigureOut">
              <a:rPr lang="ko-KR" altLang="en-US" smtClean="0"/>
              <a:t>2022-12-29</a:t>
            </a:fld>
            <a:endParaRPr lang="ko-KR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F2AEE3-607C-4FC6-98E1-D51ED38DB5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8822135-A078-4516-B813-3D78ABAF27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B0409-ECCB-4A30-B8C5-01AE5091C75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530265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DF9C88-85B2-4229-8844-B777690AA3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67F569D-9941-4635-9D0B-C8F4D31E5E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ko-KR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93255D-B11C-45B1-8978-282D7F5B46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B379BD-B1BA-4FA8-939F-D2AD2CD65319}" type="datetimeFigureOut">
              <a:rPr lang="ko-KR" altLang="en-US" smtClean="0"/>
              <a:t>2022-12-29</a:t>
            </a:fld>
            <a:endParaRPr lang="ko-KR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A39DAD-FB58-400B-BBEE-FE8CB742D9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8869CE-3989-4FC3-866D-5D853783C9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B0409-ECCB-4A30-B8C5-01AE5091C75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056135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66B641-7695-446E-9E44-C80A68830B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D8410B0-9EF0-4C2E-BB02-8A515C2178F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38CD522-9606-4106-90E2-F002AC62D3B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F0F1BD2-DC5D-4CFD-96D1-1E83023068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B379BD-B1BA-4FA8-939F-D2AD2CD65319}" type="datetimeFigureOut">
              <a:rPr lang="ko-KR" altLang="en-US" smtClean="0"/>
              <a:t>2022-12-29</a:t>
            </a:fld>
            <a:endParaRPr lang="ko-KR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269CFB8-6385-4AE3-A1F1-39E686B815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3213C9-D671-4F2D-9F66-CB187F03BD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B0409-ECCB-4A30-B8C5-01AE5091C75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150970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27718A-DFAC-4AED-A0FB-7E5B1AAB36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E5E6D95-8912-49D0-94EB-83E33C09EE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ko-KR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D39719A-4E26-4119-A2B9-17266D3489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B0DDA90-E955-4EC3-98C6-1791204D851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ko-KR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9E494F4-572C-4CF3-A077-712DB30383A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4CBDE73-8D96-461E-BDB7-C557DE13F8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B379BD-B1BA-4FA8-939F-D2AD2CD65319}" type="datetimeFigureOut">
              <a:rPr lang="ko-KR" altLang="en-US" smtClean="0"/>
              <a:t>2022-12-29</a:t>
            </a:fld>
            <a:endParaRPr lang="ko-KR" alt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A6D9745-8DAF-4D04-8F07-27E7F384C3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9471E7F-4564-40FF-902A-0272626579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B0409-ECCB-4A30-B8C5-01AE5091C75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496598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95960E-50F4-4488-9ADC-901D4C6A09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36AEC4B-3D61-402A-B276-1F23107986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B379BD-B1BA-4FA8-939F-D2AD2CD65319}" type="datetimeFigureOut">
              <a:rPr lang="ko-KR" altLang="en-US" smtClean="0"/>
              <a:t>2022-12-29</a:t>
            </a:fld>
            <a:endParaRPr lang="ko-KR" alt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90D2D04-FD34-4213-83F7-511280FA8C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643304A-B913-4ABF-ACC7-0D17AB1B3B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B0409-ECCB-4A30-B8C5-01AE5091C75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282039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3C5ECBC-CE62-4ACA-A717-C11635BCB5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B379BD-B1BA-4FA8-939F-D2AD2CD65319}" type="datetimeFigureOut">
              <a:rPr lang="ko-KR" altLang="en-US" smtClean="0"/>
              <a:t>2022-12-29</a:t>
            </a:fld>
            <a:endParaRPr lang="ko-KR" alt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5FD457D-4247-43BE-92DD-E1C566035C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BDA271A-BC1E-490C-AEAD-127D316DDC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B0409-ECCB-4A30-B8C5-01AE5091C75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499974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5EB647-9158-4124-94C7-B50C1932A8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B7B5E02-299B-4CBB-9671-DC9CC34D4D5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D43AB73-E6A3-414E-B091-5E7FB518920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ko-KR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2B8FE2F-43C3-476D-8F31-DBBCF5DBAF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B379BD-B1BA-4FA8-939F-D2AD2CD65319}" type="datetimeFigureOut">
              <a:rPr lang="ko-KR" altLang="en-US" smtClean="0"/>
              <a:t>2022-12-29</a:t>
            </a:fld>
            <a:endParaRPr lang="ko-KR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B9B35A3-36F7-4BEB-BEE2-7E515C5AB2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0571D64-571D-469F-AB2F-2F79E6EF0A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B0409-ECCB-4A30-B8C5-01AE5091C75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2966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68B643-0314-4246-B52D-5EE5D3831F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E5F5D9F-50E2-42DB-BF3A-4A6DC7C20C3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1A53941-80B9-4634-BDA3-206146F1BE3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ko-KR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0709674-0DB5-4F6C-B10C-D5B53EA5DA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B379BD-B1BA-4FA8-939F-D2AD2CD65319}" type="datetimeFigureOut">
              <a:rPr lang="ko-KR" altLang="en-US" smtClean="0"/>
              <a:t>2022-12-29</a:t>
            </a:fld>
            <a:endParaRPr lang="ko-KR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175C384-68E6-48F7-976B-AF9453BEAF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8B85FAD-417D-49B5-8879-36DCFC993B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B0409-ECCB-4A30-B8C5-01AE5091C75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280449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294FAB7-51B9-4769-8303-E742F6170B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762BBFC-15C2-483B-B860-1443C092E1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D87D32-47F2-4DB2-92E9-0775BD6CB38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B379BD-B1BA-4FA8-939F-D2AD2CD65319}" type="datetimeFigureOut">
              <a:rPr lang="ko-KR" altLang="en-US" smtClean="0"/>
              <a:t>2022-12-29</a:t>
            </a:fld>
            <a:endParaRPr lang="ko-KR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ADA0F4-8A2E-48BC-AD5F-03F19F0A4D0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4727FF-3997-477E-A630-9CC744011FD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1B0409-ECCB-4A30-B8C5-01AE5091C75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76141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8DADE7C8-7513-464B-A7ED-4FECE65511C6}"/>
              </a:ext>
            </a:extLst>
          </p:cNvPr>
          <p:cNvSpPr/>
          <p:nvPr/>
        </p:nvSpPr>
        <p:spPr>
          <a:xfrm>
            <a:off x="1557251" y="5627408"/>
            <a:ext cx="9864436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05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S1</a:t>
            </a:r>
            <a:r>
              <a:rPr lang="en-US" altLang="ko-KR" sz="105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: Morphology of A549 cells after treatment with different concentrations of </a:t>
            </a:r>
            <a:r>
              <a:rPr lang="en-US" altLang="ko-KR" sz="105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HGRCm-ZnO</a:t>
            </a:r>
            <a:r>
              <a:rPr lang="en-US" altLang="ko-KR" sz="105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NPs and cisplatin</a:t>
            </a:r>
            <a:endParaRPr lang="ko-KR" altLang="en-US" sz="1050" dirty="0"/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9EFFEC02-DBB8-4FC3-AD47-2F6D1BBF0F02}"/>
              </a:ext>
            </a:extLst>
          </p:cNvPr>
          <p:cNvGrpSpPr/>
          <p:nvPr/>
        </p:nvGrpSpPr>
        <p:grpSpPr>
          <a:xfrm>
            <a:off x="2846841" y="268252"/>
            <a:ext cx="5325609" cy="5112614"/>
            <a:chOff x="2903991" y="954052"/>
            <a:chExt cx="5325609" cy="5112614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722423BA-F6C7-4AD1-997F-95192B57ABFA}"/>
                </a:ext>
              </a:extLst>
            </p:cNvPr>
            <p:cNvGrpSpPr/>
            <p:nvPr/>
          </p:nvGrpSpPr>
          <p:grpSpPr>
            <a:xfrm>
              <a:off x="2983371" y="1001735"/>
              <a:ext cx="5246229" cy="5064931"/>
              <a:chOff x="2962785" y="3813577"/>
              <a:chExt cx="5068092" cy="3150762"/>
            </a:xfrm>
          </p:grpSpPr>
          <p:grpSp>
            <p:nvGrpSpPr>
              <p:cNvPr id="6" name="Group 5">
                <a:extLst>
                  <a:ext uri="{FF2B5EF4-FFF2-40B4-BE49-F238E27FC236}">
                    <a16:creationId xmlns:a16="http://schemas.microsoft.com/office/drawing/2014/main" id="{9011A8C6-C555-4EF2-8D71-0CEDDC3618C7}"/>
                  </a:ext>
                </a:extLst>
              </p:cNvPr>
              <p:cNvGrpSpPr/>
              <p:nvPr/>
            </p:nvGrpSpPr>
            <p:grpSpPr>
              <a:xfrm>
                <a:off x="2962785" y="3813577"/>
                <a:ext cx="5068092" cy="3150762"/>
                <a:chOff x="1896605" y="1137960"/>
                <a:chExt cx="5352850" cy="4579924"/>
              </a:xfrm>
            </p:grpSpPr>
            <p:grpSp>
              <p:nvGrpSpPr>
                <p:cNvPr id="8" name="Group 7">
                  <a:extLst>
                    <a:ext uri="{FF2B5EF4-FFF2-40B4-BE49-F238E27FC236}">
                      <a16:creationId xmlns:a16="http://schemas.microsoft.com/office/drawing/2014/main" id="{29B35AA4-0E04-4995-91ED-D29418F158CD}"/>
                    </a:ext>
                  </a:extLst>
                </p:cNvPr>
                <p:cNvGrpSpPr/>
                <p:nvPr/>
              </p:nvGrpSpPr>
              <p:grpSpPr>
                <a:xfrm>
                  <a:off x="1896605" y="1442071"/>
                  <a:ext cx="5352850" cy="4031494"/>
                  <a:chOff x="1896605" y="1442071"/>
                  <a:chExt cx="5352850" cy="4031494"/>
                </a:xfrm>
              </p:grpSpPr>
              <p:pic>
                <p:nvPicPr>
                  <p:cNvPr id="13" name="Picture 12">
                    <a:extLst>
                      <a:ext uri="{FF2B5EF4-FFF2-40B4-BE49-F238E27FC236}">
                        <a16:creationId xmlns:a16="http://schemas.microsoft.com/office/drawing/2014/main" id="{237B1F53-0CAB-4C82-885C-C1ADD6368B1F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3">
                            <a14:imgEffect>
                              <a14:sharpenSoften amount="-3000"/>
                            </a14:imgEffect>
                            <a14:imgEffect>
                              <a14:brightnessContrast bright="39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896605" y="1442071"/>
                    <a:ext cx="2664180" cy="1992891"/>
                  </a:xfrm>
                  <a:prstGeom prst="rect">
                    <a:avLst/>
                  </a:prstGeom>
                  <a:ln>
                    <a:noFill/>
                  </a:ln>
                </p:spPr>
              </p:pic>
              <p:pic>
                <p:nvPicPr>
                  <p:cNvPr id="14" name="Picture 13">
                    <a:extLst>
                      <a:ext uri="{FF2B5EF4-FFF2-40B4-BE49-F238E27FC236}">
                        <a16:creationId xmlns:a16="http://schemas.microsoft.com/office/drawing/2014/main" id="{FCB86D97-8132-4F14-BB14-3376A4497FD2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4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5">
                            <a14:imgEffect>
                              <a14:brightnessContrast bright="36000" contrast="6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4660305" y="3523592"/>
                    <a:ext cx="2589150" cy="1949973"/>
                  </a:xfrm>
                  <a:prstGeom prst="rect">
                    <a:avLst/>
                  </a:prstGeom>
                  <a:ln>
                    <a:noFill/>
                  </a:ln>
                </p:spPr>
              </p:pic>
              <p:pic>
                <p:nvPicPr>
                  <p:cNvPr id="15" name="Picture 14">
                    <a:extLst>
                      <a:ext uri="{FF2B5EF4-FFF2-40B4-BE49-F238E27FC236}">
                        <a16:creationId xmlns:a16="http://schemas.microsoft.com/office/drawing/2014/main" id="{E02B7C74-1263-4BCA-BEC1-E643AF229DA4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6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7">
                            <a14:imgEffect>
                              <a14:brightnessContrast bright="18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896605" y="3523592"/>
                    <a:ext cx="2700962" cy="1949973"/>
                  </a:xfrm>
                  <a:prstGeom prst="rect">
                    <a:avLst/>
                  </a:prstGeom>
                  <a:ln>
                    <a:noFill/>
                  </a:ln>
                </p:spPr>
              </p:pic>
            </p:grpSp>
            <p:sp>
              <p:nvSpPr>
                <p:cNvPr id="9" name="TextBox 8">
                  <a:extLst>
                    <a:ext uri="{FF2B5EF4-FFF2-40B4-BE49-F238E27FC236}">
                      <a16:creationId xmlns:a16="http://schemas.microsoft.com/office/drawing/2014/main" id="{BEA9EC38-9C23-4163-97B3-C042892818FE}"/>
                    </a:ext>
                  </a:extLst>
                </p:cNvPr>
                <p:cNvSpPr txBox="1"/>
                <p:nvPr/>
              </p:nvSpPr>
              <p:spPr>
                <a:xfrm>
                  <a:off x="2917540" y="1165071"/>
                  <a:ext cx="736339" cy="25047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Palatino Linotype" panose="02040502050505030304" pitchFamily="18" charset="0"/>
                    </a:rPr>
                    <a:t>Control</a:t>
                  </a:r>
                </a:p>
              </p:txBody>
            </p:sp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id="{4007745E-0506-4077-9E00-A57D15D8E16D}"/>
                    </a:ext>
                  </a:extLst>
                </p:cNvPr>
                <p:cNvSpPr txBox="1"/>
                <p:nvPr/>
              </p:nvSpPr>
              <p:spPr>
                <a:xfrm>
                  <a:off x="4755806" y="1137960"/>
                  <a:ext cx="2018635" cy="25047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Palatino Linotype" panose="02040502050505030304" pitchFamily="18" charset="0"/>
                    </a:rPr>
                    <a:t>HGR-ZnO NPs(20</a:t>
                  </a:r>
                  <a:r>
                    <a:rPr lang="en-US" sz="1200" b="1" dirty="0">
                      <a:latin typeface="Palatino Linotype" panose="02040502050505030304" pitchFamily="18" charset="0"/>
                      <a:cs typeface="Times New Roman" panose="02020603050405020304" pitchFamily="18" charset="0"/>
                    </a:rPr>
                    <a:t>µg/mL)</a:t>
                  </a:r>
                  <a:endParaRPr lang="en-US" sz="1200" b="1" dirty="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11" name="TextBox 10">
                  <a:extLst>
                    <a:ext uri="{FF2B5EF4-FFF2-40B4-BE49-F238E27FC236}">
                      <a16:creationId xmlns:a16="http://schemas.microsoft.com/office/drawing/2014/main" id="{DAA37C79-E94C-4632-902C-FDDD9F0351D0}"/>
                    </a:ext>
                  </a:extLst>
                </p:cNvPr>
                <p:cNvSpPr txBox="1"/>
                <p:nvPr/>
              </p:nvSpPr>
              <p:spPr>
                <a:xfrm>
                  <a:off x="4827269" y="5453640"/>
                  <a:ext cx="2227989" cy="25047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Palatino Linotype" panose="02040502050505030304" pitchFamily="18" charset="0"/>
                    </a:rPr>
                    <a:t>HGRcm-ZnO NPs(20</a:t>
                  </a:r>
                  <a:r>
                    <a:rPr lang="en-US" sz="1200" b="1" dirty="0">
                      <a:latin typeface="Palatino Linotype" panose="02040502050505030304" pitchFamily="18" charset="0"/>
                      <a:cs typeface="Times New Roman" panose="02020603050405020304" pitchFamily="18" charset="0"/>
                    </a:rPr>
                    <a:t>µg/mL)</a:t>
                  </a:r>
                  <a:endParaRPr lang="en-US" sz="1200" b="1" dirty="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12" name="TextBox 11">
                  <a:extLst>
                    <a:ext uri="{FF2B5EF4-FFF2-40B4-BE49-F238E27FC236}">
                      <a16:creationId xmlns:a16="http://schemas.microsoft.com/office/drawing/2014/main" id="{C493DBFB-BAD9-48DD-8E05-C3F0D81FD3B1}"/>
                    </a:ext>
                  </a:extLst>
                </p:cNvPr>
                <p:cNvSpPr txBox="1"/>
                <p:nvPr/>
              </p:nvSpPr>
              <p:spPr>
                <a:xfrm>
                  <a:off x="2599691" y="5467410"/>
                  <a:ext cx="1586842" cy="25047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Palatino Linotype" panose="02040502050505030304" pitchFamily="18" charset="0"/>
                    </a:rPr>
                    <a:t>Cisplatin(20</a:t>
                  </a:r>
                  <a:r>
                    <a:rPr lang="en-US" sz="1200" b="1" dirty="0">
                      <a:latin typeface="Palatino Linotype" panose="02040502050505030304" pitchFamily="18" charset="0"/>
                      <a:cs typeface="Times New Roman" panose="02020603050405020304" pitchFamily="18" charset="0"/>
                    </a:rPr>
                    <a:t>µg/mL)</a:t>
                  </a:r>
                  <a:endParaRPr lang="en-US" sz="1200" b="1" dirty="0">
                    <a:latin typeface="Palatino Linotype" panose="02040502050505030304" pitchFamily="18" charset="0"/>
                  </a:endParaRPr>
                </a:p>
              </p:txBody>
            </p:sp>
          </p:grpSp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9388F80A-8CAC-4560-A6A4-2986EEB74AC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bright="39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5553679" y="4022790"/>
                <a:ext cx="2477198" cy="1361270"/>
              </a:xfrm>
              <a:prstGeom prst="rect">
                <a:avLst/>
              </a:prstGeom>
              <a:ln>
                <a:noFill/>
              </a:ln>
            </p:spPr>
          </p:pic>
        </p:grp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D2D4CCD1-7B7D-42F1-823F-EDAF49DEFA6B}"/>
                </a:ext>
              </a:extLst>
            </p:cNvPr>
            <p:cNvSpPr txBox="1"/>
            <p:nvPr/>
          </p:nvSpPr>
          <p:spPr>
            <a:xfrm>
              <a:off x="2903991" y="954052"/>
              <a:ext cx="25146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US" b="1" dirty="0">
                <a:latin typeface="Palatino Linotype" panose="02040502050505030304" pitchFamily="18" charset="0"/>
              </a:endParaRPr>
            </a:p>
          </p:txBody>
        </p:sp>
      </p:grpSp>
      <p:sp>
        <p:nvSpPr>
          <p:cNvPr id="16" name="Rectangle 15">
            <a:extLst>
              <a:ext uri="{FF2B5EF4-FFF2-40B4-BE49-F238E27FC236}">
                <a16:creationId xmlns:a16="http://schemas.microsoft.com/office/drawing/2014/main" id="{470893B0-9005-4CA0-80C1-B073552EF678}"/>
              </a:ext>
            </a:extLst>
          </p:cNvPr>
          <p:cNvSpPr/>
          <p:nvPr/>
        </p:nvSpPr>
        <p:spPr>
          <a:xfrm>
            <a:off x="249382" y="193964"/>
            <a:ext cx="2449483" cy="458286"/>
          </a:xfrm>
          <a:prstGeom prst="rect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ko-KR" dirty="0"/>
              <a:t>Supplementary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9347575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2</TotalTime>
  <Words>39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맑은 고딕</vt:lpstr>
      <vt:lpstr>SimSun</vt:lpstr>
      <vt:lpstr>Arial</vt:lpstr>
      <vt:lpstr>Palatino Linotype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Windows 사용자</cp:lastModifiedBy>
  <cp:revision>2</cp:revision>
  <dcterms:created xsi:type="dcterms:W3CDTF">2022-12-27T12:46:16Z</dcterms:created>
  <dcterms:modified xsi:type="dcterms:W3CDTF">2022-12-29T12:30:18Z</dcterms:modified>
</cp:coreProperties>
</file>